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4" autoAdjust="0"/>
    <p:restoredTop sz="94660"/>
  </p:normalViewPr>
  <p:slideViewPr>
    <p:cSldViewPr snapToGrid="0">
      <p:cViewPr varScale="1">
        <p:scale>
          <a:sx n="194" d="100"/>
          <a:sy n="194" d="100"/>
        </p:scale>
        <p:origin x="144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855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2621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380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8671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2846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3260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218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2988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7126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4810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063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3601F-1B68-421C-928A-5F35FF163A14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2CFD7-8387-48E8-AC6D-09C2455CEE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681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3" name="그룹 772"/>
          <p:cNvGrpSpPr/>
          <p:nvPr/>
        </p:nvGrpSpPr>
        <p:grpSpPr>
          <a:xfrm>
            <a:off x="395606" y="368757"/>
            <a:ext cx="8062501" cy="6033401"/>
            <a:chOff x="395606" y="368757"/>
            <a:chExt cx="8062501" cy="6033401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5606" y="368757"/>
              <a:ext cx="8062501" cy="6033401"/>
            </a:xfrm>
            <a:prstGeom prst="rect">
              <a:avLst/>
            </a:prstGeom>
          </p:spPr>
        </p:pic>
        <p:sp>
          <p:nvSpPr>
            <p:cNvPr id="772" name="직사각형 771"/>
            <p:cNvSpPr/>
            <p:nvPr/>
          </p:nvSpPr>
          <p:spPr>
            <a:xfrm>
              <a:off x="574046" y="445376"/>
              <a:ext cx="7705396" cy="3074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 </a:t>
              </a:r>
              <a:r>
                <a:rPr lang="en-US" altLang="ko-KR" sz="1000" b="1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ials 3. Distribution of patients (n=number) according to intervals between diagnosis, starting ART, and all cause of death</a:t>
              </a:r>
              <a:endParaRPr lang="ko-KR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42868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4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</cp:revision>
  <dcterms:created xsi:type="dcterms:W3CDTF">2023-09-18T12:01:32Z</dcterms:created>
  <dcterms:modified xsi:type="dcterms:W3CDTF">2024-09-18T07:34:04Z</dcterms:modified>
</cp:coreProperties>
</file>